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73152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6" d="100"/>
          <a:sy n="56" d="100"/>
        </p:scale>
        <p:origin x="155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A63AB9-D39A-4CBA-9B25-873B9DE87C8D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DB2F12-8872-46C7-B2CE-6FED633D4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965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47DC-B77E-4EA3-BA81-072EA806850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8B18-172E-4468-B81E-7C989E68B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370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47DC-B77E-4EA3-BA81-072EA806850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A8B18-172E-4468-B81E-7C989E68B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98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347DC-B77E-4EA3-BA81-072EA806850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1A8B18-172E-4468-B81E-7C989E68B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320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1" r:id="rId2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AC7597D-FAC2-AD25-5650-FF00FBA1557E}"/>
              </a:ext>
            </a:extLst>
          </p:cNvPr>
          <p:cNvGrpSpPr/>
          <p:nvPr/>
        </p:nvGrpSpPr>
        <p:grpSpPr>
          <a:xfrm>
            <a:off x="543150" y="812161"/>
            <a:ext cx="5997585" cy="4522937"/>
            <a:chOff x="-5997585" y="3411904"/>
            <a:chExt cx="5997585" cy="4522937"/>
          </a:xfrm>
          <a:solidFill>
            <a:schemeClr val="bg1"/>
          </a:solidFill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97B1498-BC24-F8E9-0F0C-34FA4FE87D5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5997585" y="6303407"/>
              <a:ext cx="1735924" cy="1631432"/>
            </a:xfrm>
            <a:prstGeom prst="rect">
              <a:avLst/>
            </a:prstGeom>
            <a:grpFill/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824325F-8A0D-1FF4-E8DD-31289806818E}"/>
                </a:ext>
              </a:extLst>
            </p:cNvPr>
            <p:cNvSpPr txBox="1"/>
            <p:nvPr/>
          </p:nvSpPr>
          <p:spPr>
            <a:xfrm>
              <a:off x="-5538465" y="5726877"/>
              <a:ext cx="966931" cy="46166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ulin alone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13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671C3F9-8C10-7E9A-C097-ADB39ECD5B3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3939778" y="6303407"/>
              <a:ext cx="1735926" cy="1631434"/>
            </a:xfrm>
            <a:prstGeom prst="rect">
              <a:avLst/>
            </a:prstGeom>
            <a:grpFill/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A76A6E4-19B1-9382-E30A-DED8DC6F91F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1881969" y="6303407"/>
              <a:ext cx="1735926" cy="1631434"/>
            </a:xfrm>
            <a:prstGeom prst="rect">
              <a:avLst/>
            </a:prstGeom>
            <a:grpFill/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5735CDF-4B74-4AF6-A6AB-13213F7F47DE}"/>
                </a:ext>
              </a:extLst>
            </p:cNvPr>
            <p:cNvSpPr txBox="1"/>
            <p:nvPr/>
          </p:nvSpPr>
          <p:spPr>
            <a:xfrm>
              <a:off x="-1860958" y="5726877"/>
              <a:ext cx="1860958" cy="46166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ulin + SCFA-producers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1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47259CC-8C90-E1FA-7D76-CDA6D5299D00}"/>
                </a:ext>
              </a:extLst>
            </p:cNvPr>
            <p:cNvSpPr txBox="1"/>
            <p:nvPr/>
          </p:nvSpPr>
          <p:spPr>
            <a:xfrm>
              <a:off x="-3862716" y="5726877"/>
              <a:ext cx="1735924" cy="46166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CFA-producers alone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13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6BEC4D65-7DA4-68D8-69EE-428A9B50652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4814554" y="4006479"/>
              <a:ext cx="1735924" cy="1631433"/>
            </a:xfrm>
            <a:prstGeom prst="rect">
              <a:avLst/>
            </a:prstGeom>
            <a:grpFill/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074B9E2-87E3-9155-F387-EE9C7D45E857}"/>
                </a:ext>
              </a:extLst>
            </p:cNvPr>
            <p:cNvSpPr txBox="1"/>
            <p:nvPr/>
          </p:nvSpPr>
          <p:spPr>
            <a:xfrm>
              <a:off x="-4814553" y="3414560"/>
              <a:ext cx="1874519" cy="461665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tact Microbiome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4DE1E395-F0ED-F41C-703D-2CD2608FA01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2804286" y="4003824"/>
              <a:ext cx="1735924" cy="1631432"/>
            </a:xfrm>
            <a:prstGeom prst="rect">
              <a:avLst/>
            </a:prstGeom>
            <a:grpFill/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99724A6-ECC7-C383-C69D-A080727DB5BC}"/>
                </a:ext>
              </a:extLst>
            </p:cNvPr>
            <p:cNvSpPr txBox="1"/>
            <p:nvPr/>
          </p:nvSpPr>
          <p:spPr>
            <a:xfrm>
              <a:off x="-2914352" y="3411904"/>
              <a:ext cx="2092087" cy="461665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epleted Microbiome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4</a:t>
              </a:r>
            </a:p>
          </p:txBody>
        </p:sp>
      </p:grpSp>
      <p:sp>
        <p:nvSpPr>
          <p:cNvPr id="17" name="Rectangle 16">
            <a:extLst>
              <a:ext uri="{FF2B5EF4-FFF2-40B4-BE49-F238E27FC236}">
                <a16:creationId xmlns:a16="http://schemas.microsoft.com/office/drawing/2014/main" id="{8B9F4B6B-A22A-B8DD-0BB6-3AEB19BE16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34799" y="973194"/>
            <a:ext cx="379707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b="1" dirty="0">
                <a:latin typeface="Arial" panose="020B0604020202020204" pitchFamily="34" charset="0"/>
                <a:ea typeface="Calibri" panose="020F0502020204030204" pitchFamily="34" charset="0"/>
              </a:rPr>
              <a:t>A.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                       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27A2C6E-5758-9F04-9B93-96D037A831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753" y="3272777"/>
            <a:ext cx="410155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b="1" dirty="0">
                <a:latin typeface="Arial" panose="020B0604020202020204" pitchFamily="34" charset="0"/>
                <a:ea typeface="Calibri" panose="020F0502020204030204" pitchFamily="34" charset="0"/>
              </a:rPr>
              <a:t>C.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                       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4FB46834-9CB1-E1EE-BBAE-1F3E138C87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1371" y="961398"/>
            <a:ext cx="410155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b="1" dirty="0">
                <a:latin typeface="Arial" panose="020B0604020202020204" pitchFamily="34" charset="0"/>
                <a:ea typeface="Calibri" panose="020F0502020204030204" pitchFamily="34" charset="0"/>
              </a:rPr>
              <a:t>B.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                       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3CAF234-BE7D-B38A-DC9B-39B761FEA9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3688" y="3272777"/>
            <a:ext cx="410155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b="1" dirty="0">
                <a:latin typeface="Arial" panose="020B0604020202020204" pitchFamily="34" charset="0"/>
                <a:ea typeface="Calibri" panose="020F0502020204030204" pitchFamily="34" charset="0"/>
              </a:rPr>
              <a:t>E.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                       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B5713EB5-9F7D-3692-5DC7-4067D48578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5879" y="3272777"/>
            <a:ext cx="410155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b="1" dirty="0">
                <a:latin typeface="Arial" panose="020B0604020202020204" pitchFamily="34" charset="0"/>
                <a:ea typeface="Calibri" panose="020F0502020204030204" pitchFamily="34" charset="0"/>
              </a:rPr>
              <a:t>D.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                       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4684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36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to-Menker, Carly</dc:creator>
  <cp:lastModifiedBy>Amato-Menker, Carly</cp:lastModifiedBy>
  <cp:revision>15</cp:revision>
  <dcterms:created xsi:type="dcterms:W3CDTF">2023-12-18T14:07:30Z</dcterms:created>
  <dcterms:modified xsi:type="dcterms:W3CDTF">2023-12-18T14:34:42Z</dcterms:modified>
</cp:coreProperties>
</file>